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2" d="100"/>
          <a:sy n="82" d="100"/>
        </p:scale>
        <p:origin x="150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3396040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44136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54825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8651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691308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3995179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951228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2197336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22443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61838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859394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C94C1D-8B43-47D6-8658-B40A27033078}" type="datetimeFigureOut">
              <a:rPr lang="pl-PL" smtClean="0"/>
              <a:t>2022-06-01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E38894-79F0-4F41-B94A-1D9CB74E92B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33554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pl-PL"/>
          </a:p>
        </p:txBody>
      </p:sp>
      <p:pic>
        <p:nvPicPr>
          <p:cNvPr id="4" name="Obraz 3"/>
          <p:cNvPicPr>
            <a:picLocks noChangeAspect="1"/>
          </p:cNvPicPr>
          <p:nvPr/>
        </p:nvPicPr>
        <p:blipFill rotWithShape="1">
          <a:blip r:embed="rId2"/>
          <a:srcRect t="3765" r="4177" b="4214"/>
          <a:stretch/>
        </p:blipFill>
        <p:spPr>
          <a:xfrm>
            <a:off x="351296" y="0"/>
            <a:ext cx="8387352" cy="6752983"/>
          </a:xfrm>
          <a:prstGeom prst="rect">
            <a:avLst/>
          </a:prstGeom>
        </p:spPr>
      </p:pic>
      <p:sp>
        <p:nvSpPr>
          <p:cNvPr id="5" name="Elipsa 7"/>
          <p:cNvSpPr/>
          <p:nvPr/>
        </p:nvSpPr>
        <p:spPr>
          <a:xfrm>
            <a:off x="3566724" y="1400249"/>
            <a:ext cx="229425" cy="227488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6" name="Elipsa 7"/>
          <p:cNvSpPr/>
          <p:nvPr/>
        </p:nvSpPr>
        <p:spPr>
          <a:xfrm>
            <a:off x="1915724" y="4001294"/>
            <a:ext cx="229425" cy="227488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7" name="Elipsa 7"/>
          <p:cNvSpPr/>
          <p:nvPr/>
        </p:nvSpPr>
        <p:spPr>
          <a:xfrm>
            <a:off x="1667249" y="4795044"/>
            <a:ext cx="229425" cy="227488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8" name="Elipsa 7"/>
          <p:cNvSpPr/>
          <p:nvPr/>
        </p:nvSpPr>
        <p:spPr>
          <a:xfrm>
            <a:off x="3337299" y="4642882"/>
            <a:ext cx="229425" cy="227488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9" name="Elipsa 7"/>
          <p:cNvSpPr/>
          <p:nvPr/>
        </p:nvSpPr>
        <p:spPr>
          <a:xfrm>
            <a:off x="3884224" y="5487194"/>
            <a:ext cx="229425" cy="227488"/>
          </a:xfrm>
          <a:prstGeom prst="ellipse">
            <a:avLst/>
          </a:prstGeom>
          <a:noFill/>
          <a:ln w="28575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0" name="Prostokąt 9"/>
          <p:cNvSpPr/>
          <p:nvPr/>
        </p:nvSpPr>
        <p:spPr>
          <a:xfrm>
            <a:off x="4116825" y="3060701"/>
            <a:ext cx="226576" cy="512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pl-PL"/>
          </a:p>
        </p:txBody>
      </p:sp>
      <p:sp>
        <p:nvSpPr>
          <p:cNvPr id="12" name="pole tekstowe 11">
            <a:extLst>
              <a:ext uri="{FF2B5EF4-FFF2-40B4-BE49-F238E27FC236}">
                <a16:creationId xmlns:a16="http://schemas.microsoft.com/office/drawing/2014/main" id="{5EA52139-5A4B-0EEA-6396-85720593AC4D}"/>
              </a:ext>
            </a:extLst>
          </p:cNvPr>
          <p:cNvSpPr txBox="1"/>
          <p:nvPr/>
        </p:nvSpPr>
        <p:spPr>
          <a:xfrm>
            <a:off x="68577" y="5022532"/>
            <a:ext cx="3426767" cy="18954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0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. Fig. 1. </a:t>
            </a:r>
            <a:r>
              <a:rPr lang="en-US" sz="1000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igborNet</a:t>
            </a:r>
            <a:r>
              <a:rPr lang="en-US" sz="10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en-US" sz="1000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ulsatilla patens</a:t>
            </a:r>
            <a:r>
              <a:rPr lang="en-US" sz="10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onstructed on ISSR loci using Dice distance. Branch support values are based on bootstrap analysis with 1000 replicates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pl-PL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–  plants from natural population in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Łagiewniki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ear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usko-Zdrój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BZ – seedlings from seeds harvested in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Łagiewniki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ear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usko-Zdrój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R – regenerated plants from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Łagiewniki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ear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usko-Zdrój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Łagiewniki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eedling explants, K (encircled) – plants from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olimagi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near </a:t>
            </a:r>
            <a:r>
              <a:rPr lang="en-US" sz="1000" b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olno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(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atura 2000 „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asanki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 </a:t>
            </a:r>
            <a:r>
              <a:rPr lang="en-US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Kolimagach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”, NE Poland)</a:t>
            </a:r>
            <a:r>
              <a:rPr lang="en-US" sz="1000" b="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000" b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ack of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genetic </a:t>
            </a:r>
            <a:r>
              <a:rPr lang="pl-PL" sz="10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ariability</a:t>
            </a:r>
            <a:r>
              <a:rPr lang="pl-PL" sz="1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with the highest bootstrap value (45.4)</a:t>
            </a:r>
            <a:r>
              <a:rPr lang="pl-PL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between some of the (BZ), (</a:t>
            </a:r>
            <a:r>
              <a:rPr lang="pl-PL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</a:t>
            </a:r>
            <a:r>
              <a:rPr lang="en-US" sz="1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(K) plants.</a:t>
            </a:r>
            <a:endParaRPr lang="pl-PL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5835696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8</TotalTime>
  <Words>115</Words>
  <Application>Microsoft Office PowerPoint</Application>
  <PresentationFormat>Pokaz na ekranie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Andrzej</dc:creator>
  <cp:lastModifiedBy>Aneta Słomka</cp:lastModifiedBy>
  <cp:revision>8</cp:revision>
  <dcterms:created xsi:type="dcterms:W3CDTF">2021-08-19T11:02:58Z</dcterms:created>
  <dcterms:modified xsi:type="dcterms:W3CDTF">2022-06-02T06:41:31Z</dcterms:modified>
</cp:coreProperties>
</file>